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00" autoAdjust="0"/>
    <p:restoredTop sz="47080" autoAdjust="0"/>
  </p:normalViewPr>
  <p:slideViewPr>
    <p:cSldViewPr snapToGrid="0">
      <p:cViewPr varScale="1">
        <p:scale>
          <a:sx n="34" d="100"/>
          <a:sy n="34" d="100"/>
        </p:scale>
        <p:origin x="2460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FFC2446-6CAB-4A9C-B4EB-47C570802183}" type="datetimeFigureOut">
              <a:rPr lang="en-GB" smtClean="0"/>
              <a:t>25/10/2022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1B6787E-2F00-4B7C-9E83-D6A8EB33C2E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9112068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2  Expression of ACE2 and spike protein</a:t>
            </a:r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</a:t>
            </a:r>
            <a:r>
              <a:rPr lang="en-GB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A)</a:t>
            </a:r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Western blot of ACE2 from 2.5x10</a:t>
            </a:r>
            <a:r>
              <a:rPr lang="en-GB" sz="1200" kern="1200" baseline="300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5</a:t>
            </a:r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293T, 293T-ACE2 and 293T-ACE2-TMPRSS2 cells together with serial dilutions of recombinant ACE2 protein.  </a:t>
            </a:r>
            <a:r>
              <a:rPr lang="en-GB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B)</a:t>
            </a:r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Western blot of SARS-CoV-2 spike protein from 2.5x10</a:t>
            </a:r>
            <a:r>
              <a:rPr lang="en-GB" sz="1200" kern="1200" baseline="300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5</a:t>
            </a:r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empty vector- and spike protein-transfected 293T cells together with serial dilutions of recombinant spike protein.   A longer exposure of the empty vector- and spike protein-transfected 293T cells is presented on the right-hand panel.  S0=full-length </a:t>
            </a:r>
            <a:r>
              <a:rPr lang="en-GB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cleaved</a:t>
            </a:r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spike protein; S1 &amp; S2 are the two sub-units of the spike protein.  TGX stain-free gels show equal loading of total proteins. </a:t>
            </a:r>
          </a:p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1B6787E-2F00-4B7C-9E83-D6A8EB33C2E2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7272403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3DCF11-5FDB-4406-8A8D-6A8154E9D548}" type="datetimeFigureOut">
              <a:rPr lang="en-GB" smtClean="0"/>
              <a:t>25/10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DB575A-C663-4E5C-8C7A-D24FCF916C8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362983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3DCF11-5FDB-4406-8A8D-6A8154E9D548}" type="datetimeFigureOut">
              <a:rPr lang="en-GB" smtClean="0"/>
              <a:t>25/10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DB575A-C663-4E5C-8C7A-D24FCF916C8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784355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3DCF11-5FDB-4406-8A8D-6A8154E9D548}" type="datetimeFigureOut">
              <a:rPr lang="en-GB" smtClean="0"/>
              <a:t>25/10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DB575A-C663-4E5C-8C7A-D24FCF916C8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434604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3DCF11-5FDB-4406-8A8D-6A8154E9D548}" type="datetimeFigureOut">
              <a:rPr lang="en-GB" smtClean="0"/>
              <a:t>25/10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DB575A-C663-4E5C-8C7A-D24FCF916C8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289951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3DCF11-5FDB-4406-8A8D-6A8154E9D548}" type="datetimeFigureOut">
              <a:rPr lang="en-GB" smtClean="0"/>
              <a:t>25/10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DB575A-C663-4E5C-8C7A-D24FCF916C8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395794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3DCF11-5FDB-4406-8A8D-6A8154E9D548}" type="datetimeFigureOut">
              <a:rPr lang="en-GB" smtClean="0"/>
              <a:t>25/10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DB575A-C663-4E5C-8C7A-D24FCF916C8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651048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3DCF11-5FDB-4406-8A8D-6A8154E9D548}" type="datetimeFigureOut">
              <a:rPr lang="en-GB" smtClean="0"/>
              <a:t>25/10/202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DB575A-C663-4E5C-8C7A-D24FCF916C8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042607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3DCF11-5FDB-4406-8A8D-6A8154E9D548}" type="datetimeFigureOut">
              <a:rPr lang="en-GB" smtClean="0"/>
              <a:t>25/10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DB575A-C663-4E5C-8C7A-D24FCF916C8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119318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3DCF11-5FDB-4406-8A8D-6A8154E9D548}" type="datetimeFigureOut">
              <a:rPr lang="en-GB" smtClean="0"/>
              <a:t>25/10/202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DB575A-C663-4E5C-8C7A-D24FCF916C8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38232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3DCF11-5FDB-4406-8A8D-6A8154E9D548}" type="datetimeFigureOut">
              <a:rPr lang="en-GB" smtClean="0"/>
              <a:t>25/10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DB575A-C663-4E5C-8C7A-D24FCF916C8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043045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3DCF11-5FDB-4406-8A8D-6A8154E9D548}" type="datetimeFigureOut">
              <a:rPr lang="en-GB" smtClean="0"/>
              <a:t>25/10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DB575A-C663-4E5C-8C7A-D24FCF916C8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598291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3DCF11-5FDB-4406-8A8D-6A8154E9D548}" type="datetimeFigureOut">
              <a:rPr lang="en-GB" smtClean="0"/>
              <a:t>25/10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DB575A-C663-4E5C-8C7A-D24FCF916C8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703981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7" Type="http://schemas.openxmlformats.org/officeDocument/2006/relationships/image" Target="../media/image5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89349" y="2192067"/>
            <a:ext cx="2649878" cy="75558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89349" y="3168401"/>
            <a:ext cx="2636510" cy="317651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173100" y="1722372"/>
            <a:ext cx="2286880" cy="123774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585023" y="1722372"/>
            <a:ext cx="841185" cy="123774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149768" y="3184276"/>
            <a:ext cx="2313831" cy="316064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2" name="TextBox 11"/>
          <p:cNvSpPr txBox="1"/>
          <p:nvPr/>
        </p:nvSpPr>
        <p:spPr>
          <a:xfrm>
            <a:off x="3474358" y="2242385"/>
            <a:ext cx="8953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>
                <a:latin typeface="Arial" panose="020B0604020202020204" pitchFamily="34" charset="0"/>
                <a:cs typeface="Arial" panose="020B0604020202020204" pitchFamily="34" charset="0"/>
              </a:rPr>
              <a:t>ACE2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8511782" y="1759787"/>
            <a:ext cx="466794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latin typeface="Arial" panose="020B0604020202020204" pitchFamily="34" charset="0"/>
                <a:cs typeface="Arial" panose="020B0604020202020204" pitchFamily="34" charset="0"/>
              </a:rPr>
              <a:t>S0</a:t>
            </a:r>
          </a:p>
          <a:p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GB" dirty="0" smtClean="0">
                <a:latin typeface="Arial" panose="020B0604020202020204" pitchFamily="34" charset="0"/>
                <a:cs typeface="Arial" panose="020B0604020202020204" pitchFamily="34" charset="0"/>
              </a:rPr>
              <a:t>S1</a:t>
            </a:r>
          </a:p>
          <a:p>
            <a:r>
              <a:rPr lang="en-GB" dirty="0" smtClean="0">
                <a:latin typeface="Arial" panose="020B0604020202020204" pitchFamily="34" charset="0"/>
                <a:cs typeface="Arial" panose="020B0604020202020204" pitchFamily="34" charset="0"/>
              </a:rPr>
              <a:t>S2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6" name="Straight Arrow Connector 25"/>
          <p:cNvCxnSpPr/>
          <p:nvPr/>
        </p:nvCxnSpPr>
        <p:spPr>
          <a:xfrm flipH="1">
            <a:off x="3234507" y="2486201"/>
            <a:ext cx="235131" cy="150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Arrow Connector 27"/>
          <p:cNvCxnSpPr/>
          <p:nvPr/>
        </p:nvCxnSpPr>
        <p:spPr>
          <a:xfrm flipH="1">
            <a:off x="8426208" y="2022481"/>
            <a:ext cx="171569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Arrow Connector 29"/>
          <p:cNvCxnSpPr/>
          <p:nvPr/>
        </p:nvCxnSpPr>
        <p:spPr>
          <a:xfrm flipH="1">
            <a:off x="8426208" y="2729283"/>
            <a:ext cx="171569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Arrow Connector 31"/>
          <p:cNvCxnSpPr/>
          <p:nvPr/>
        </p:nvCxnSpPr>
        <p:spPr>
          <a:xfrm flipH="1">
            <a:off x="8408390" y="2556390"/>
            <a:ext cx="171569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32"/>
          <p:cNvSpPr txBox="1"/>
          <p:nvPr/>
        </p:nvSpPr>
        <p:spPr>
          <a:xfrm rot="16200000">
            <a:off x="1030024" y="49329"/>
            <a:ext cx="1755160" cy="24929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</a:p>
          <a:p>
            <a:endParaRPr lang="en-GB" sz="12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</a:p>
          <a:p>
            <a:endParaRPr lang="en-GB" sz="12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0.1</a:t>
            </a:r>
          </a:p>
          <a:p>
            <a:endParaRPr lang="en-GB" sz="12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0.05</a:t>
            </a:r>
          </a:p>
          <a:p>
            <a:endParaRPr lang="en-GB" sz="12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293T</a:t>
            </a:r>
          </a:p>
          <a:p>
            <a:endParaRPr lang="en-GB" sz="12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293T-ACE2</a:t>
            </a:r>
          </a:p>
          <a:p>
            <a:endParaRPr lang="en-GB" sz="12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293T-ACE2-TMPRSS2</a:t>
            </a:r>
          </a:p>
        </p:txBody>
      </p:sp>
      <p:sp>
        <p:nvSpPr>
          <p:cNvPr id="34" name="TextBox 33"/>
          <p:cNvSpPr txBox="1"/>
          <p:nvPr/>
        </p:nvSpPr>
        <p:spPr>
          <a:xfrm rot="16200000">
            <a:off x="6198684" y="-310217"/>
            <a:ext cx="1082348" cy="30469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</a:p>
          <a:p>
            <a:endParaRPr lang="en-GB" sz="12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</a:p>
          <a:p>
            <a:endParaRPr lang="en-GB" sz="12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0.1</a:t>
            </a:r>
          </a:p>
          <a:p>
            <a:endParaRPr lang="en-GB" sz="12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0.05</a:t>
            </a:r>
          </a:p>
          <a:p>
            <a:endParaRPr lang="en-GB" sz="12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empty vector</a:t>
            </a:r>
          </a:p>
          <a:p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ARS-2-S</a:t>
            </a:r>
          </a:p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GB" sz="12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empty vector</a:t>
            </a:r>
          </a:p>
          <a:p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ARS-2-S</a:t>
            </a:r>
          </a:p>
        </p:txBody>
      </p:sp>
      <p:sp>
        <p:nvSpPr>
          <p:cNvPr id="35" name="TextBox 34"/>
          <p:cNvSpPr txBox="1"/>
          <p:nvPr/>
        </p:nvSpPr>
        <p:spPr>
          <a:xfrm>
            <a:off x="3474358" y="4351869"/>
            <a:ext cx="194543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>
                <a:latin typeface="Arial" panose="020B0604020202020204" pitchFamily="34" charset="0"/>
                <a:cs typeface="Arial" panose="020B0604020202020204" pitchFamily="34" charset="0"/>
              </a:rPr>
              <a:t>TGX-stained gels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370528" y="1325275"/>
            <a:ext cx="195232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ecombinant ACE2 (</a:t>
            </a:r>
            <a:r>
              <a:rPr lang="en-GB" sz="1200" dirty="0" smtClean="0">
                <a:latin typeface="Symbol" panose="05050102010706020507" pitchFamily="18" charset="2"/>
                <a:cs typeface="Arial" panose="020B0604020202020204" pitchFamily="34" charset="0"/>
              </a:rPr>
              <a:t>m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g)   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Left Bracket 36"/>
          <p:cNvSpPr/>
          <p:nvPr/>
        </p:nvSpPr>
        <p:spPr>
          <a:xfrm rot="5400000">
            <a:off x="1251630" y="1073321"/>
            <a:ext cx="223995" cy="1405039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8" name="Left Bracket 37"/>
          <p:cNvSpPr/>
          <p:nvPr/>
        </p:nvSpPr>
        <p:spPr>
          <a:xfrm rot="5400000">
            <a:off x="5868969" y="622755"/>
            <a:ext cx="223995" cy="1405039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9" name="TextBox 38"/>
          <p:cNvSpPr txBox="1"/>
          <p:nvPr/>
        </p:nvSpPr>
        <p:spPr>
          <a:xfrm>
            <a:off x="5004801" y="893161"/>
            <a:ext cx="18774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ecombinant spike (</a:t>
            </a:r>
            <a:r>
              <a:rPr lang="en-GB" sz="1200" dirty="0" smtClean="0">
                <a:latin typeface="Symbol" panose="05050102010706020507" pitchFamily="18" charset="2"/>
                <a:cs typeface="Arial" panose="020B0604020202020204" pitchFamily="34" charset="0"/>
              </a:rPr>
              <a:t>m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g)   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6542902" y="194209"/>
            <a:ext cx="183415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ransfected   transfected</a:t>
            </a:r>
          </a:p>
          <a:p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    293T             </a:t>
            </a:r>
            <a:r>
              <a:rPr lang="en-GB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293T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Left Bracket 40"/>
          <p:cNvSpPr/>
          <p:nvPr/>
        </p:nvSpPr>
        <p:spPr>
          <a:xfrm rot="5400000">
            <a:off x="6914464" y="408669"/>
            <a:ext cx="210398" cy="672354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2" name="Left Bracket 41"/>
          <p:cNvSpPr/>
          <p:nvPr/>
        </p:nvSpPr>
        <p:spPr>
          <a:xfrm rot="5400000">
            <a:off x="7798381" y="408669"/>
            <a:ext cx="210398" cy="672354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3" name="TextBox 42"/>
          <p:cNvSpPr txBox="1"/>
          <p:nvPr/>
        </p:nvSpPr>
        <p:spPr>
          <a:xfrm>
            <a:off x="123785" y="6416058"/>
            <a:ext cx="158569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  <a:endParaRPr lang="en-GB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7552114" y="3021129"/>
            <a:ext cx="1027845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lang="en-GB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onger </a:t>
            </a:r>
          </a:p>
          <a:p>
            <a:r>
              <a:rPr lang="en-GB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exposure</a:t>
            </a:r>
            <a:endParaRPr lang="en-GB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166786" y="177982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GB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4369728" y="118966"/>
            <a:ext cx="48483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GB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025588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03</TotalTime>
  <Words>152</Words>
  <Application>Microsoft Office PowerPoint</Application>
  <PresentationFormat>On-screen Show (4:3)</PresentationFormat>
  <Paragraphs>4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Symbol</vt:lpstr>
      <vt:lpstr>Office Theme</vt:lpstr>
      <vt:lpstr>PowerPoint Presentation</vt:lpstr>
    </vt:vector>
  </TitlesOfParts>
  <Company>University of Mancheste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iu-Wan Chan</dc:creator>
  <cp:lastModifiedBy>Shiu-Wan Chan</cp:lastModifiedBy>
  <cp:revision>11</cp:revision>
  <dcterms:created xsi:type="dcterms:W3CDTF">2022-10-12T08:47:11Z</dcterms:created>
  <dcterms:modified xsi:type="dcterms:W3CDTF">2022-10-25T17:43:20Z</dcterms:modified>
</cp:coreProperties>
</file>